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png" ContentType="image/png"/>
  <Override PartName="/ppt/media/image3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34654F-FB50-4125-8B61-8E2579E17B0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C1C323-6FC3-4415-9D27-E5CBE684227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4A6A01-CB6E-4A77-A860-A63BFB2DE68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954C68-2BA1-4B57-8FD9-B005E919433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7FC7FC-FA2F-455D-824A-818554E72B6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89ED47-4C63-4E16-BAA6-3C02534986D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2BCBD0-1639-4F4F-8CE3-757319AAE89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9726EA-5B94-4494-9F47-3C640FA19EB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A0723D-8B1A-4BCC-ADDA-B5690FD3D35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407FF6-81C3-4DA0-B66F-BCFCEA3AAB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7A0AE8-F080-44AA-8CF1-9D06B8152F2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25EF5F-199E-4EED-8D7D-AEB6ABBC96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E3B52E7-71BB-4763-9610-A200232B9AC2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image" Target="../media/image2.jpeg"/><Relationship Id="rId4" Type="http://schemas.openxmlformats.org/officeDocument/2006/relationships/image" Target="../media/image3.jpe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8440" y="1687680"/>
            <a:ext cx="5348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ffffff"/>
                </a:solidFill>
                <a:latin typeface="Arial"/>
              </a:rPr>
              <a:t>UW C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119160" y="125280"/>
          <a:ext cx="2962080" cy="19638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3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19160" y="125280"/>
                    <a:ext cx="2962080" cy="196380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pic>
        <p:nvPicPr>
          <p:cNvPr id="44" name="" descr=""/>
          <p:cNvPicPr/>
          <p:nvPr/>
        </p:nvPicPr>
        <p:blipFill>
          <a:blip r:embed="rId3"/>
          <a:srcRect l="0" t="0" r="0" b="11965"/>
          <a:stretch/>
        </p:blipFill>
        <p:spPr>
          <a:xfrm>
            <a:off x="119160" y="2171880"/>
            <a:ext cx="2971800" cy="1962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5" name="" descr=""/>
          <p:cNvPicPr/>
          <p:nvPr/>
        </p:nvPicPr>
        <p:blipFill>
          <a:blip r:embed="rId4"/>
          <a:srcRect l="23610" t="31476" r="24933" b="23110"/>
          <a:stretch/>
        </p:blipFill>
        <p:spPr>
          <a:xfrm>
            <a:off x="123840" y="4216320"/>
            <a:ext cx="2968560" cy="19652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6" name=""/>
          <p:cNvSpPr/>
          <p:nvPr/>
        </p:nvSpPr>
        <p:spPr>
          <a:xfrm>
            <a:off x="115200" y="6675480"/>
            <a:ext cx="66211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Supplementary Figur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Representative graft morphology for kidney lost during follow u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3197880" y="55440"/>
            <a:ext cx="471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D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3131280" y="2103480"/>
            <a:ext cx="598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D1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3125160" y="4168800"/>
            <a:ext cx="598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D2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CHU1208</cp:lastModifiedBy>
  <dcterms:modified xsi:type="dcterms:W3CDTF">2010-08-04T13:24:21Z</dcterms:modified>
  <cp:revision>9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